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557"/>
    <p:restoredTop sz="95439"/>
  </p:normalViewPr>
  <p:slideViewPr>
    <p:cSldViewPr snapToGrid="0">
      <p:cViewPr>
        <p:scale>
          <a:sx n="100" d="100"/>
          <a:sy n="100" d="100"/>
        </p:scale>
        <p:origin x="720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6738B-29DE-FA5B-3427-48FF72E672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D1132E-0D82-CFF6-2352-CE6FE3A892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D3A708-858F-B4E0-EA34-F802FC5F3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EE68C7-697E-2FD4-DF7F-096EAFDEE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F87DB-E573-C842-0DDC-5759B916A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504432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01601-F33C-B1D1-B7B2-CF35CCCB1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1EC004-9C36-94C1-D03F-8CB169E9A7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5B9C27-C429-F38D-DF3B-9FC06D79E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A3348B-18A3-E018-DC1B-F67373921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E4D73C-061A-8698-75F5-B62CD52CB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635311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44127D-73D8-AFAC-CFAC-4B610079C0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C978A9-11AA-3EEF-A157-990C34834B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A56C6A-512B-27FD-B764-9790D9F9C8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2F2D27-ECA7-7C78-5F8F-955CE8997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A10E6C-AFA0-A60E-0031-7C9752A6A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447555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5D20AE-7E73-1F78-1F99-76204D587A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12B84C-791C-001C-DF8B-46254C20B8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4A7D57-1818-D2FA-891E-62C8AD4CA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C7768-D10E-2498-C743-1C2BC8ED8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417B8A-C144-C244-A2A8-FDFC6AC7F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34133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DAC96-6A52-FC11-E4D0-B396EDB157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AB3B62-D8BE-0FA2-A145-B69627FA7F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E8717C-8DA8-F928-4249-FFDC10964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76E692-5DEE-C826-7F0E-E3DA3BC21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149C4A-5933-19D9-A183-503308FDF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042692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A7D612-FE39-C123-56CF-828BA96EC9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DE7F57-C484-C9C1-30F3-3B9EE4AF72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A3DCAF-2030-8BA7-4A5C-69B66857F9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636082-F960-D032-7CFB-68EEC73A1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BD4203-DFC8-A8E2-D59B-20E691B98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E86FDA-ADFD-1950-F012-78E899014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873405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B5BA6-B680-2BDE-FEA1-8F5E38A48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BCCB9A-B1EB-25DF-12E5-0A16BAF11D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2CC306-2956-FA5D-D931-204C21CFCC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295EB1-B363-4718-D311-E7B3CD1F2B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B73F12A-27C5-157D-0BF2-83EFB5EDAE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AF5D22-4899-9A12-FA47-6F29F579E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96CDD6-B578-700A-7944-FC1C1B48D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C94BD7-1E28-36F8-7094-D8E4ED2BD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938610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C73631-5BBC-A5F9-F587-1F3CEF0DA7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E4E703-B838-07A7-832C-50FCAAD84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A054E7-927F-1D21-034E-17B1F6A78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9208250-0BF4-D4B5-0C72-EB7A47C48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523181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12A8C2-5EB5-B04F-D5B7-F5274D69C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5E0FC7-7591-02EF-5E0B-ADF019F6C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19DF524-292C-288D-6EEB-3EA89D8D0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060930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292215-4BB3-4898-F0CA-D2FE359E1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40E165-1840-8164-9D84-7E791A960D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2C3548-9A9F-FAC4-5057-6B1C6DB5DB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7A1F29-C38D-2B54-8DCE-FCBA84402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389893-AC0A-926F-23A5-22AB83755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0E6636-EACE-4735-0AA1-A2845DF81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035803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01C13-7662-2319-0E34-40F87BC3F2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022B50-60A4-02CE-2B0C-E94E8F805E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9C3EBF-CFEC-6672-214F-A4422B3E8B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636B76-356F-3D6B-1831-2513A7652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D00848-7D11-7A05-F21C-CE363AB63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DC5EC2-0A07-C0B0-29D8-7323AFE6A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479091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F805AA-0198-60B4-C0F7-65C6BF6A6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0D86DE-009A-31DF-F2A3-E1EDFDFFEE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44E200-4FBC-9C9B-A5A7-DF9B47A3AB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1592D-D6BD-D149-9C7E-4FFFCAC25187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D3F4E6-0B5C-4E5F-E6ED-D881872F74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4BC06F-665E-A54A-86B0-89F8B53A03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AE393-484F-AC47-B530-4655B8C86F42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488492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B136778-C726-FE60-1C53-C3E17DA984BA}"/>
              </a:ext>
            </a:extLst>
          </p:cNvPr>
          <p:cNvSpPr txBox="1"/>
          <p:nvPr/>
        </p:nvSpPr>
        <p:spPr>
          <a:xfrm>
            <a:off x="0" y="1956786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Additional File 4: Figure S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6D03D0C-1E7A-AA28-31FC-01F19CDCDDF6}"/>
              </a:ext>
            </a:extLst>
          </p:cNvPr>
          <p:cNvSpPr txBox="1"/>
          <p:nvPr/>
        </p:nvSpPr>
        <p:spPr>
          <a:xfrm>
            <a:off x="1759777" y="3048385"/>
            <a:ext cx="9104245" cy="1315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nished </a:t>
            </a:r>
            <a:r>
              <a:rPr lang="en-US" sz="2800" b="1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</a:t>
            </a:r>
            <a:r>
              <a:rPr lang="en-US" sz="2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PA–CRISPR/Cas12a reaction tubes exposed to UV light.</a:t>
            </a:r>
            <a:r>
              <a:rPr lang="en-TH" sz="28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TH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304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47C3264D-F861-1C7A-CF96-AD57AC8462DB}"/>
              </a:ext>
            </a:extLst>
          </p:cNvPr>
          <p:cNvSpPr txBox="1"/>
          <p:nvPr/>
        </p:nvSpPr>
        <p:spPr>
          <a:xfrm>
            <a:off x="0" y="250422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4: Figure S2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Finished </a:t>
            </a:r>
            <a:r>
              <a:rPr lang="en-US" i="1" dirty="0" err="1">
                <a:latin typeface="Arial" panose="020B0604020202020204" pitchFamily="34" charset="0"/>
                <a:cs typeface="Arial" panose="020B0604020202020204" pitchFamily="34" charset="0"/>
              </a:rPr>
              <a:t>Ov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RPA–CRISPR/Cas12a reaction tubes exposed to UV light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61AAD25-C8B4-EE12-02A7-BDCF049B87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" y="766776"/>
            <a:ext cx="6160400" cy="604042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F4F5B2E-A55B-C49D-4E55-8CFEDEF3A3DC}"/>
              </a:ext>
            </a:extLst>
          </p:cNvPr>
          <p:cNvSpPr txBox="1"/>
          <p:nvPr/>
        </p:nvSpPr>
        <p:spPr>
          <a:xfrm>
            <a:off x="6671312" y="3194139"/>
            <a:ext cx="4979054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thaiDist"/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4: Figure S2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TH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TH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image shows the exposure of finished reaction tubes (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RPA–CRISPR/Cas12a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to UV light.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be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C: negative control (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pro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NA, healthy fecal sample), Tubes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4: </a:t>
            </a:r>
            <a:r>
              <a:rPr lang="en-US" sz="12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</a:t>
            </a:r>
            <a:r>
              <a:rPr lang="en-US" sz="1200" i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verrini</a:t>
            </a:r>
            <a:r>
              <a:rPr lang="en-US" sz="12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sitive fecal samples (Sample IDs: Ov01–Ov04), Tube PC: positive control (plasmid containing </a:t>
            </a:r>
            <a:r>
              <a:rPr lang="en-US" sz="12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</a:t>
            </a:r>
            <a:r>
              <a:rPr lang="en-US" sz="1200" i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verrini</a:t>
            </a:r>
            <a:r>
              <a:rPr lang="en-US" sz="12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AD1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). All reaction tubes were visually inspected using an UV transilluminator and photographed using a phone camera. </a:t>
            </a:r>
            <a:r>
              <a:rPr lang="en-TH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TH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image shows agarose gel electrophoresis results of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urified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PA products obtained from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nished reactions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l gelctrophoresis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’s label is based on image A. T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 target amplicon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 were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81 bp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red arrowhead)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ube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C: negative control, Tubes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10: </a:t>
            </a:r>
            <a:r>
              <a:rPr lang="en-US" sz="12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. </a:t>
            </a:r>
            <a:r>
              <a:rPr lang="en-US" sz="1200" i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ichui</a:t>
            </a:r>
            <a:r>
              <a:rPr lang="en-US" sz="12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sitive fecal samples (Sample IDs: Ht01–Ht10), Tube PC: positive control.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l gelctrophoresis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’s label is based on image C.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be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C: negative control, Tubes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10: negative fecal samples (Sample IDs: N01–N10), Tube PC: positive control.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)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l gelctrophoresis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’s label is based on image E.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G)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be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C: negative control, Tubes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12: positive other helminth fecal samples (Sample IDs: Al01–Al03, Tt01–Tt03, Hw01–Hw03, and Tae01–Tae03), Tube PC: positive control.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H)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</a:t>
            </a:r>
            <a:r>
              <a:rPr lang="en-TH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l gelctrophoresis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’s label is based on image G. </a:t>
            </a:r>
            <a:endParaRPr lang="en-TH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4747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6</TotalTime>
  <Words>322</Words>
  <Application>Microsoft Macintosh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21</cp:revision>
  <dcterms:created xsi:type="dcterms:W3CDTF">2023-07-20T02:38:52Z</dcterms:created>
  <dcterms:modified xsi:type="dcterms:W3CDTF">2024-02-19T07:53:10Z</dcterms:modified>
</cp:coreProperties>
</file>